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29" r:id="rId2"/>
    <p:sldId id="330" r:id="rId3"/>
  </p:sldIdLst>
  <p:sldSz cx="6264275" cy="842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9877"/>
    <a:srgbClr val="EEBC96"/>
    <a:srgbClr val="F4D4D4"/>
    <a:srgbClr val="F3D7D1"/>
    <a:srgbClr val="6087CE"/>
    <a:srgbClr val="4674C6"/>
    <a:srgbClr val="83ABD7"/>
    <a:srgbClr val="26457C"/>
    <a:srgbClr val="4472C4"/>
    <a:srgbClr val="9FB7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51" autoAdjust="0"/>
    <p:restoredTop sz="94198" autoAdjust="0"/>
  </p:normalViewPr>
  <p:slideViewPr>
    <p:cSldViewPr>
      <p:cViewPr varScale="1">
        <p:scale>
          <a:sx n="81" d="100"/>
          <a:sy n="81" d="100"/>
        </p:scale>
        <p:origin x="3360" y="84"/>
      </p:cViewPr>
      <p:guideLst>
        <p:guide orient="horz" pos="2653"/>
        <p:guide pos="19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5FF59-7695-48F5-AB78-39D11FDC9794}" type="datetimeFigureOut">
              <a:rPr lang="ko-KR" altLang="en-US" smtClean="0"/>
              <a:t>2025-08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43000"/>
            <a:ext cx="229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6247F1-F2E7-41F9-89F3-984DCCE2D2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75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966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18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60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650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20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59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61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581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33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401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ABF44-6F9F-4425-AB37-2FBDA0F51D67}" type="datetimeFigureOut">
              <a:rPr lang="en-US" smtClean="0"/>
              <a:pPr/>
              <a:t>8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21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1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1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B5165BDD-8A37-40F1-9CD9-F994F48275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1977" y="403602"/>
            <a:ext cx="3675600" cy="2340000"/>
          </a:xfrm>
          <a:prstGeom prst="rect">
            <a:avLst/>
          </a:prstGeom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64633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#6-C1-1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403602"/>
            <a:ext cx="8018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B</a:t>
            </a: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5B9845A-4AEE-46C4-A853-BBC9DF53C4DD}"/>
              </a:ext>
            </a:extLst>
          </p:cNvPr>
          <p:cNvSpPr/>
          <p:nvPr/>
        </p:nvSpPr>
        <p:spPr>
          <a:xfrm>
            <a:off x="3240149" y="147433"/>
            <a:ext cx="12763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gRNA target region</a:t>
            </a:r>
          </a:p>
        </p:txBody>
      </p:sp>
      <p:pic>
        <p:nvPicPr>
          <p:cNvPr id="19" name="그림 18">
            <a:extLst>
              <a:ext uri="{FF2B5EF4-FFF2-40B4-BE49-F238E27FC236}">
                <a16:creationId xmlns:a16="http://schemas.microsoft.com/office/drawing/2014/main" id="{9F632384-081D-4979-8B89-85C08B51A5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1977" y="2843485"/>
            <a:ext cx="3686945" cy="2340000"/>
          </a:xfrm>
          <a:prstGeom prst="rect">
            <a:avLst/>
          </a:prstGeom>
        </p:spPr>
      </p:pic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2843485"/>
            <a:ext cx="80983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C</a:t>
            </a: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5271781"/>
            <a:ext cx="80983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D</a:t>
            </a: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3B54158F-72A8-4E56-A363-5C3F9B5661AA}"/>
              </a:ext>
            </a:extLst>
          </p:cNvPr>
          <p:cNvSpPr/>
          <p:nvPr/>
        </p:nvSpPr>
        <p:spPr>
          <a:xfrm>
            <a:off x="-211" y="7632017"/>
            <a:ext cx="6264275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4.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mplicon sequencing of mutants detected by HRM analysis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ious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reenshot shows the guide sequence target region in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B10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#6-C1-1 (A) and #8-C2-3 (B). </a:t>
            </a:r>
          </a:p>
          <a:p>
            <a:pPr algn="just"/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37E51EA5-A5EC-4307-B4C7-F1C979FACE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977" y="5287090"/>
            <a:ext cx="3686400" cy="2346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78654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036D30CD-EE4B-4E66-B8D0-2B8C9C9EFCF9}"/>
              </a:ext>
            </a:extLst>
          </p:cNvPr>
          <p:cNvSpPr/>
          <p:nvPr/>
        </p:nvSpPr>
        <p:spPr>
          <a:xfrm>
            <a:off x="460903" y="23069"/>
            <a:ext cx="64633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#8-C2-3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71187190-3C19-40CA-ADF8-66C8F0903EB6}"/>
              </a:ext>
            </a:extLst>
          </p:cNvPr>
          <p:cNvSpPr/>
          <p:nvPr/>
        </p:nvSpPr>
        <p:spPr>
          <a:xfrm>
            <a:off x="215813" y="7680"/>
            <a:ext cx="28725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AFF86616-7746-4B22-9F18-7917C21C0B9A}"/>
              </a:ext>
            </a:extLst>
          </p:cNvPr>
          <p:cNvSpPr/>
          <p:nvPr/>
        </p:nvSpPr>
        <p:spPr>
          <a:xfrm>
            <a:off x="460903" y="403602"/>
            <a:ext cx="8018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B</a:t>
            </a: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5B9845A-4AEE-46C4-A853-BBC9DF53C4DD}"/>
              </a:ext>
            </a:extLst>
          </p:cNvPr>
          <p:cNvSpPr/>
          <p:nvPr/>
        </p:nvSpPr>
        <p:spPr>
          <a:xfrm>
            <a:off x="3060129" y="147433"/>
            <a:ext cx="12763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gRNA target region</a:t>
            </a: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48ABE38-6EB3-41F7-8EDA-7DE8C4893837}"/>
              </a:ext>
            </a:extLst>
          </p:cNvPr>
          <p:cNvSpPr/>
          <p:nvPr/>
        </p:nvSpPr>
        <p:spPr>
          <a:xfrm>
            <a:off x="460903" y="2843485"/>
            <a:ext cx="80983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C</a:t>
            </a: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8151AB6-69C3-436D-8543-201C371FF281}"/>
              </a:ext>
            </a:extLst>
          </p:cNvPr>
          <p:cNvSpPr/>
          <p:nvPr/>
        </p:nvSpPr>
        <p:spPr>
          <a:xfrm>
            <a:off x="460903" y="5271781"/>
            <a:ext cx="80983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i="1" dirty="0">
                <a:latin typeface="Arial" panose="020B0604020202020204" pitchFamily="34" charset="0"/>
                <a:cs typeface="Arial" panose="020B0604020202020204" pitchFamily="34" charset="0"/>
              </a:rPr>
              <a:t>MYB10-1D</a:t>
            </a: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2B764265-44BF-44FE-B8C5-8C7324D844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1977" y="403602"/>
            <a:ext cx="3681793" cy="23400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FC37AA7F-420A-41D3-91FA-453689CB18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1977" y="2843485"/>
            <a:ext cx="3692643" cy="2340000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EA75EA8F-CDD3-4E7B-8ACE-9BA4571100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1977" y="5271781"/>
            <a:ext cx="3719907" cy="2340000"/>
          </a:xfrm>
          <a:prstGeom prst="rect">
            <a:avLst/>
          </a:prstGeom>
        </p:spPr>
      </p:pic>
      <p:sp>
        <p:nvSpPr>
          <p:cNvPr id="16" name="직사각형 15">
            <a:extLst>
              <a:ext uri="{FF2B5EF4-FFF2-40B4-BE49-F238E27FC236}">
                <a16:creationId xmlns:a16="http://schemas.microsoft.com/office/drawing/2014/main" id="{44CAFA3A-03C6-4538-A804-7B075D64EED6}"/>
              </a:ext>
            </a:extLst>
          </p:cNvPr>
          <p:cNvSpPr/>
          <p:nvPr/>
        </p:nvSpPr>
        <p:spPr>
          <a:xfrm>
            <a:off x="-211" y="7632017"/>
            <a:ext cx="6264275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4.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Continued.</a:t>
            </a:r>
          </a:p>
          <a:p>
            <a:pPr algn="just"/>
            <a:endParaRPr lang="en-US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389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93</TotalTime>
  <Words>60</Words>
  <Application>Microsoft Office PowerPoint</Application>
  <PresentationFormat>사용자 지정</PresentationFormat>
  <Paragraphs>14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9" baseType="lpstr">
      <vt:lpstr>맑은 고딕</vt:lpstr>
      <vt:lpstr>바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e Yoon Kim</dc:creator>
  <cp:lastModifiedBy>이만보</cp:lastModifiedBy>
  <cp:revision>298</cp:revision>
  <dcterms:created xsi:type="dcterms:W3CDTF">2012-09-21T02:05:55Z</dcterms:created>
  <dcterms:modified xsi:type="dcterms:W3CDTF">2025-08-29T12:57:59Z</dcterms:modified>
</cp:coreProperties>
</file>